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14747168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31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49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C9B7E7-7514-4FDF-89ED-9084BFC5CF7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C606D9-A797-48B1-9AFD-4CBBF8F924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87616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Alveolar</a:t>
            </a:r>
            <a:r>
              <a:rPr kumimoji="1" lang="ja-JP" altLang="en-US" dirty="0"/>
              <a:t>：アルビーラ　肺胞　空気を含んだ、泡沫状の構造物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E2891E3-1DA4-466F-9341-EA7E27B672DE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30652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D104E0-4C2D-3AAA-9F0F-22C481A052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A4159A6-5016-7DB9-2393-39A22D6647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4C336A-5781-AC87-2FFB-C51F3BB8F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C03BFC-9B33-88AC-343C-E01A57182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1EACB7-2C44-3761-165E-90AABF35E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933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06592D-267C-B742-4B44-D522C850A2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E15BCCA-380E-E109-0307-11E6560CE9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C88DBC-60E7-0AA4-C5CE-79B1453A4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B4D558-E483-C050-B2BB-6560720BF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B0CC09-ABC7-903F-40F7-3F2BEBEE5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5186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096E9AC-F488-B661-A1DB-853204987B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E7C9032-9BB4-9464-0484-D142F1B5FB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BAFD66-89AE-EDDB-D332-467043965E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1B06ED3-6A3C-778B-5589-5FEF870B5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41FA75-165E-BACF-7484-83C07FAE9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309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F5CA3B-4C6D-1915-A3D4-6D0C33E790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1E8BC3F-5BB0-5B14-DA41-773B2559F6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14D579-2777-9607-7935-18909A78F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16852D-302F-D6AA-AB02-D84306F1A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5ED7F5-A76E-DBE5-BBBB-9A726DDED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834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0CB130-3722-4B58-6846-2908E1EE1E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40F0AEE-DA1C-5F4B-0CDD-28A1886348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2260A8-6CF7-107A-750F-2857BAA0A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42E9CC-4A3E-0FF4-25D9-354FF7E45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8924ED-6AD1-340F-90EA-5ADAA6E81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9045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88AF17-7F91-ECD0-566C-C83C7F0CF9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EEC45A6-055B-509A-99A4-F647327338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58DBF0-35A1-DF29-644A-6EC68BF807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5B6767F-32D1-B120-E61A-1609EBF4B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D7D85A-3047-5C97-9B83-E1FEE771B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A1BC9E-7AB0-EAE8-6F9E-255F534C9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475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3C6A69-6FE4-D7B7-C035-0DB317CBCB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2C6348C-CD0C-4FCA-6951-611D78D852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B1E8F9C-4D8B-A467-FD2D-9EA7FC4B72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F03E58F-C3B3-0954-3553-DD54F55689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28BA934-0FEC-52D5-75AF-971C399928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2AAD3C1-8CAF-FCC2-2B49-808721AFB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CDB08B5-9647-B385-7B34-B9C5DDD56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EE6EFF4-2C72-D89F-496A-1AB14DD9F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5146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2F688A-0639-3B9B-506B-C212CE53E9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564F4AE-5450-992E-A624-1A0A6EF2E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F7AE5F2-AA03-6C4E-74D6-1E1B22DF5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DFDBCAC-4AE9-0B20-10C0-EA0E7BD7F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4633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D9DBBA6-0AA0-5678-6A1C-BE91B602F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D6D60B2-CB90-5E45-8208-0BA6F4C25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42B92DD-A16E-6434-9977-998C187BC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4458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CA0927-4541-471C-6FA4-448FC4E8BE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57962F1-7BE9-AA08-9695-82AF640BF8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567B006-5634-2558-5146-BA241BE802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648F7CB-5BF4-AA23-72DB-F92F20AB8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DC1E43-7FE3-F25E-5738-97463AE43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350A13D-80B0-D562-B311-574DD3DF5A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3886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D36C3B-00B0-ACDE-5F32-EACE5E37AE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C008B30-3196-D4F2-B668-6931CFB579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08BF5E8-1643-8D3A-D13B-999F956704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2B6ABF6-9F55-3371-C8CF-836A005B9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109C65-AB28-9CD2-567A-D7ED51173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66C0AB-4DAF-1D3C-D982-F521609D8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386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680D866-64CE-1E77-9EEC-4836C5445A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DD9D1A-9ED2-EE55-9942-3662FFB6BA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93B4E2-6970-E59C-6B6B-2684867A43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7451CC-DA78-4741-BD49-95C1177D2B8B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719645-62DA-8961-3C18-F256F93282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372824-3895-00F6-AA53-D3B6CEBCB9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B7129B-A872-4EB5-8579-B7B261E504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7496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478B5E4B-CD6B-437B-9937-89A60CDA8F06}"/>
              </a:ext>
            </a:extLst>
          </p:cNvPr>
          <p:cNvGrpSpPr/>
          <p:nvPr/>
        </p:nvGrpSpPr>
        <p:grpSpPr>
          <a:xfrm>
            <a:off x="3057388" y="651316"/>
            <a:ext cx="6592329" cy="2272270"/>
            <a:chOff x="2866768" y="1563130"/>
            <a:chExt cx="6592329" cy="2272270"/>
          </a:xfrm>
        </p:grpSpPr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CE62AD14-E784-4E87-822F-613DC251BA0F}"/>
                </a:ext>
              </a:extLst>
            </p:cNvPr>
            <p:cNvSpPr/>
            <p:nvPr/>
          </p:nvSpPr>
          <p:spPr>
            <a:xfrm>
              <a:off x="2866768" y="1563130"/>
              <a:ext cx="5863281" cy="227227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41ACE2F1-2B89-4C19-91CA-9BC270B3C301}"/>
                </a:ext>
              </a:extLst>
            </p:cNvPr>
            <p:cNvSpPr txBox="1"/>
            <p:nvPr/>
          </p:nvSpPr>
          <p:spPr>
            <a:xfrm>
              <a:off x="3384376" y="2109482"/>
              <a:ext cx="5586627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buFont typeface="Wingdings" panose="05000000000000000000" pitchFamily="2" charset="2"/>
                <a:buChar char="ü"/>
              </a:pPr>
              <a:r>
                <a:rPr kumimoji="1"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 cT1/T2, N0</a:t>
              </a:r>
              <a:endParaRPr lang="en-US" altLang="ja-JP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285750" indent="-285750">
                <a:buFont typeface="Wingdings" panose="05000000000000000000" pitchFamily="2" charset="2"/>
                <a:buChar char="ü"/>
              </a:pPr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 Located within 5cm from AV</a:t>
              </a:r>
            </a:p>
            <a:p>
              <a:pPr marL="285750" indent="-285750">
                <a:buFont typeface="Wingdings" panose="05000000000000000000" pitchFamily="2" charset="2"/>
                <a:buChar char="ü"/>
              </a:pPr>
              <a:r>
                <a:rPr kumimoji="1"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 Laparoscopic surgery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66DF4C91-C62E-4C58-8140-971C3385EFC6}"/>
                </a:ext>
              </a:extLst>
            </p:cNvPr>
            <p:cNvSpPr txBox="1"/>
            <p:nvPr/>
          </p:nvSpPr>
          <p:spPr>
            <a:xfrm>
              <a:off x="4924168" y="3299429"/>
              <a:ext cx="156930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(N = 299)</a:t>
              </a:r>
              <a:endParaRPr kumimoji="1"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D188CBD-5380-4B39-9FCA-D6A3095ABD2F}"/>
                </a:ext>
              </a:extLst>
            </p:cNvPr>
            <p:cNvSpPr txBox="1"/>
            <p:nvPr/>
          </p:nvSpPr>
          <p:spPr>
            <a:xfrm>
              <a:off x="3478427" y="1608475"/>
              <a:ext cx="598067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Ultimate trial (Primary analysis)</a:t>
              </a:r>
              <a:endPara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CF16EB38-7C7D-4BCE-9963-2F3549C5E1F9}"/>
              </a:ext>
            </a:extLst>
          </p:cNvPr>
          <p:cNvSpPr/>
          <p:nvPr/>
        </p:nvSpPr>
        <p:spPr>
          <a:xfrm>
            <a:off x="2750012" y="3469938"/>
            <a:ext cx="6478031" cy="19943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C00E86C-F145-4801-9C6A-6CA38AF8EA69}"/>
              </a:ext>
            </a:extLst>
          </p:cNvPr>
          <p:cNvSpPr txBox="1"/>
          <p:nvPr/>
        </p:nvSpPr>
        <p:spPr>
          <a:xfrm>
            <a:off x="3099092" y="3575383"/>
            <a:ext cx="59806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The present study (Subgroup analysis)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B77DDFD-158E-4786-98A2-A4F867553F85}"/>
              </a:ext>
            </a:extLst>
          </p:cNvPr>
          <p:cNvSpPr txBox="1"/>
          <p:nvPr/>
        </p:nvSpPr>
        <p:spPr>
          <a:xfrm>
            <a:off x="3574996" y="4094999"/>
            <a:ext cx="45843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ü"/>
            </a:pP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phincter-preserved case</a:t>
            </a:r>
          </a:p>
          <a:p>
            <a:pPr marL="342900" indent="-342900">
              <a:buFont typeface="Wingdings" panose="05000000000000000000" pitchFamily="2" charset="2"/>
              <a:buChar char="ü"/>
            </a:pP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 R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eturned questionnaires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59F65D0-8409-4784-80B6-8E0FBF09513B}"/>
              </a:ext>
            </a:extLst>
          </p:cNvPr>
          <p:cNvSpPr txBox="1"/>
          <p:nvPr/>
        </p:nvSpPr>
        <p:spPr>
          <a:xfrm>
            <a:off x="5114788" y="4912882"/>
            <a:ext cx="15693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(N = 259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221FEE2C-B3FD-4316-8135-D9BC5ABA5118}"/>
              </a:ext>
            </a:extLst>
          </p:cNvPr>
          <p:cNvCxnSpPr>
            <a:cxnSpLocks/>
          </p:cNvCxnSpPr>
          <p:nvPr/>
        </p:nvCxnSpPr>
        <p:spPr>
          <a:xfrm flipH="1">
            <a:off x="5806152" y="2923586"/>
            <a:ext cx="1" cy="54635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296E9D03-F4F5-45ED-AFA9-E116BB0C1758}"/>
              </a:ext>
            </a:extLst>
          </p:cNvPr>
          <p:cNvCxnSpPr>
            <a:cxnSpLocks/>
          </p:cNvCxnSpPr>
          <p:nvPr/>
        </p:nvCxnSpPr>
        <p:spPr>
          <a:xfrm flipH="1">
            <a:off x="5806152" y="5460479"/>
            <a:ext cx="1" cy="54635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0CFB6F75-3AC4-4CB5-A258-5FCFE355B9C2}"/>
              </a:ext>
            </a:extLst>
          </p:cNvPr>
          <p:cNvSpPr/>
          <p:nvPr/>
        </p:nvSpPr>
        <p:spPr>
          <a:xfrm>
            <a:off x="4387703" y="6006831"/>
            <a:ext cx="2884967" cy="4577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D9A19AA-6366-48CC-8A7A-3751841A22F1}"/>
              </a:ext>
            </a:extLst>
          </p:cNvPr>
          <p:cNvSpPr txBox="1"/>
          <p:nvPr/>
        </p:nvSpPr>
        <p:spPr>
          <a:xfrm>
            <a:off x="5199849" y="6002930"/>
            <a:ext cx="21862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69499CD-50F6-2520-2A80-88F943083FC0}"/>
              </a:ext>
            </a:extLst>
          </p:cNvPr>
          <p:cNvSpPr txBox="1"/>
          <p:nvPr/>
        </p:nvSpPr>
        <p:spPr>
          <a:xfrm>
            <a:off x="524592" y="222845"/>
            <a:ext cx="19200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altLang="ja-JP" sz="2000" dirty="0" err="1">
                <a:latin typeface="Arial" panose="020B0604020202020204" pitchFamily="34" charset="0"/>
                <a:cs typeface="Arial" panose="020B0604020202020204" pitchFamily="34" charset="0"/>
              </a:rPr>
              <a:t>upplementary</a:t>
            </a:r>
            <a:r>
              <a:rPr lang="en-GB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 Figure 1.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15207253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.7|3.9|4.8|6.6|6.6|0.7|0.7|0.8"/>
</p:tagLst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2</Words>
  <Application>Microsoft Office PowerPoint</Application>
  <PresentationFormat>ワイド画面</PresentationFormat>
  <Paragraphs>1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Wingding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宏喜 濱元</dc:creator>
  <cp:lastModifiedBy>宏喜 濱元</cp:lastModifiedBy>
  <cp:revision>2</cp:revision>
  <dcterms:created xsi:type="dcterms:W3CDTF">2025-06-08T02:25:50Z</dcterms:created>
  <dcterms:modified xsi:type="dcterms:W3CDTF">2025-06-08T02:29:32Z</dcterms:modified>
</cp:coreProperties>
</file>